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907588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5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5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98ECCED-8845-4FBF-BC13-3EE932C332F4}" type="datetime">
              <a:rPr b="0" lang="it-IT" sz="1200" spc="-1" strike="noStrike">
                <a:solidFill>
                  <a:srgbClr val="000000"/>
                </a:solidFill>
                <a:latin typeface="Arial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11040" y="746280"/>
            <a:ext cx="2575080" cy="37209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88200" rIns="88200" tIns="44280" bIns="4428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31280"/>
            <a:ext cx="2946240" cy="49536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31280"/>
            <a:ext cx="2946240" cy="495360"/>
          </a:xfrm>
          <a:prstGeom prst="rect">
            <a:avLst/>
          </a:prstGeom>
          <a:noFill/>
          <a:ln w="0">
            <a:noFill/>
          </a:ln>
        </p:spPr>
        <p:txBody>
          <a:bodyPr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74335B0-7966-4D3E-A614-9754E4A3ECD1}" type="slidenum">
              <a:rPr b="0" lang="it-IT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sldImg"/>
          </p:nvPr>
        </p:nvSpPr>
        <p:spPr>
          <a:xfrm>
            <a:off x="2111400" y="746280"/>
            <a:ext cx="2575080" cy="3720960"/>
          </a:xfrm>
          <a:prstGeom prst="rect">
            <a:avLst/>
          </a:prstGeom>
          <a:ln w="0">
            <a:noFill/>
          </a:ln>
        </p:spPr>
      </p:sp>
      <p:sp>
        <p:nvSpPr>
          <p:cNvPr id="51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Segnaposto numero diapositiva 3"/>
          <p:cNvSpPr/>
          <p:nvPr/>
        </p:nvSpPr>
        <p:spPr>
          <a:xfrm>
            <a:off x="3849840" y="9431280"/>
            <a:ext cx="2946240" cy="49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AB5ED3F-3B9D-4AFA-A2E3-67D86E8B9426}" type="slidenum">
              <a:rPr b="0" lang="it-IT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84681D-76A2-4288-B0A0-64E84D957DA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30E095-A108-43AD-98F2-8AA729A0B0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3E341A-58CE-4377-A06F-79766DF2DD2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4AA219-9E67-480C-BB42-C920A868B7B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6F9AC2-CA3F-43ED-81CE-59FCFCF120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9BA783-FF92-4003-9CA9-BB7DF606EE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C81C6B-EADF-486E-9A01-9181AC354E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D65630-857F-4C29-95CD-591A95D90C1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6080B9-DACB-4B43-9B2C-FDD3AEF9F6A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DBAFB9-6F4B-4684-A7C9-8CF84409D7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7EED0A-5530-4BF1-90FC-8060B320C0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C416F5-5C58-4DE3-BE1B-FE3A420AE2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19800"/>
            <a:ext cx="217152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8D22CCB-A136-4FBC-96FE-1958B10B7323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"/>
          <p:cNvGraphicFramePr/>
          <p:nvPr/>
        </p:nvGraphicFramePr>
        <p:xfrm>
          <a:off x="1397160" y="1339920"/>
          <a:ext cx="4001760" cy="5956200"/>
        </p:xfrm>
        <a:graphic>
          <a:graphicData uri="http://schemas.openxmlformats.org/drawingml/2006/table">
            <a:tbl>
              <a:tblPr/>
              <a:tblGrid>
                <a:gridCol w="634680"/>
                <a:gridCol w="668520"/>
                <a:gridCol w="1209600"/>
                <a:gridCol w="593640"/>
                <a:gridCol w="895320"/>
              </a:tblGrid>
              <a:tr h="37764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Vcod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ccess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ocatio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W(mg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DW/FW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yl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ranc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3 ± 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78±0.0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Je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ranc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0±1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86±0.00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36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l-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aly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20±1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84±0.00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980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-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wede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1±2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76±0.00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Kn-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ithuani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89±3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85±0.00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8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Edi-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K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49±5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73±0.00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36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su-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Japa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40±1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73±0.00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tw-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ussi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760±4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98±0.02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980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9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t-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Liby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76±1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71±0.00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36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0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e-0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witzerlan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2±6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93±0.00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5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a-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arocco 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98±6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92±0.00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t-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taly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45±6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88±0.00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36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n-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a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8±6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82±0.00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980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vi-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ape Verde Island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5±6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89±0.00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ur-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Irelan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23±6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81±0.00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lc-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pai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6±3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81±0.00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36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Blh-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zechoslovaki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2±3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93±0.00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0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Gre-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S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92±6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74±0.00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980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1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Mh-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olan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80±9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73±0.00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36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y-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orway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02±9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75±0.00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h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adjikista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626±7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68±0.00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kit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Japa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50±7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65±0.00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36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5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akat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Japan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30±6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68±0.00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980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6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N1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ussi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20±9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01±0.01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86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ol-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USA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49±9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400" rIns="6840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83±0.00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400" marR="68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2240"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AVERAG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44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8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9836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SD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00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360"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V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68760" rIns="68760" tIns="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3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68760" marR="687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5400" bIns="0" anchor="ctr">
                      <a:noAutofit/>
                    </a:bodyPr>
                    <a:p>
                      <a:pPr algn="ctr">
                        <a:lnSpc>
                          <a:spcPct val="115000"/>
                        </a:lnSpc>
                        <a:tabLst>
                          <a:tab algn="l" pos="0"/>
                          <a:tab algn="l" pos="8892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.1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9" name="Rettangolo 1"/>
          <p:cNvSpPr/>
          <p:nvPr/>
        </p:nvSpPr>
        <p:spPr>
          <a:xfrm>
            <a:off x="704880" y="7943760"/>
            <a:ext cx="548640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ble S2: Information about ecotypes included in the Nested core collection from INRA including Col-0 and biomass yield. </a:t>
            </a:r>
            <a:r>
              <a:rPr b="0" lang="en-GB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Versailles identification number (AV), the name of accession, its geographical location, fresh weight (FW) of aerial vegetative portion of plants and dry weight (DW)/FW ratio are reported. Data represent the average ± SD of at least six plants. Average, standard deviation and coefficient of variation calculated from the entire collection are reporte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6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1-09T23:56:23Z</dcterms:created>
  <dc:creator>Utenti</dc:creator>
  <dc:description/>
  <dc:language>en-US</dc:language>
  <cp:lastModifiedBy>Daniela Bellincampi</cp:lastModifiedBy>
  <cp:lastPrinted>2013-07-05T13:42:32Z</cp:lastPrinted>
  <dcterms:modified xsi:type="dcterms:W3CDTF">2013-09-25T17:01:48Z</dcterms:modified>
  <cp:revision>288</cp:revision>
  <dc:subject/>
  <dc:title>Diapositiva 1</dc:title>
</cp:coreProperties>
</file>